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185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1999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5265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0389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3077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225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3558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2737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6924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0630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94516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0208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C02EC-3C46-466B-8915-A144591BA25F}" type="datetimeFigureOut">
              <a:rPr lang="fr-FR" smtClean="0"/>
              <a:t>1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1F020-4933-4525-909E-3339FC237FB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3698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 descr="F:\Projets\Drépano\Moya Moya\Figure 1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476672"/>
            <a:ext cx="4139565" cy="392366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5"/>
          <p:cNvSpPr/>
          <p:nvPr/>
        </p:nvSpPr>
        <p:spPr>
          <a:xfrm>
            <a:off x="683568" y="4797152"/>
            <a:ext cx="7704856" cy="19834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fr-FR" b="1" dirty="0" err="1">
                <a:effectLst/>
                <a:latin typeface="Times New Roman"/>
                <a:ea typeface="Calibri"/>
                <a:cs typeface="Times New Roman"/>
              </a:rPr>
              <a:t>Supplementary</a:t>
            </a:r>
            <a:r>
              <a:rPr lang="fr-FR" b="1" dirty="0">
                <a:effectLst/>
                <a:latin typeface="Times New Roman"/>
                <a:ea typeface="Calibri"/>
                <a:cs typeface="Times New Roman"/>
              </a:rPr>
              <a:t> Figure 1 (10). </a:t>
            </a:r>
            <a:r>
              <a:rPr lang="fr-FR" dirty="0">
                <a:effectLst/>
                <a:latin typeface="Times New Roman"/>
                <a:ea typeface="Calibri"/>
                <a:cs typeface="Times New Roman"/>
              </a:rPr>
              <a:t>Moyamoya-vessel (MMV) score (13). </a:t>
            </a:r>
            <a:r>
              <a:rPr lang="en-US" dirty="0">
                <a:effectLst/>
                <a:latin typeface="Times New Roman"/>
                <a:ea typeface="Calibri"/>
                <a:cs typeface="Times New Roman"/>
              </a:rPr>
              <a:t>MMV score ranges from 0 to 5 based on 5 areas of collateral arteries of the circle of Willis, including: 1. anterior communicating artery (ACoA) 2. basal ganglia 3. middle cerebral artery (MCA)/internal carotid artery (ICA) 4. posterior communicating artery (PCoA)/posterior cerebral artery (PCA) 5. basilar artery (BA).</a:t>
            </a:r>
            <a:endParaRPr lang="fr-FR" sz="16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5519651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8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owerPoint Presentation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AUV Paul</dc:creator>
  <cp:lastModifiedBy>Mollie McCormick</cp:lastModifiedBy>
  <cp:revision>12</cp:revision>
  <dcterms:created xsi:type="dcterms:W3CDTF">2018-02-14T10:19:42Z</dcterms:created>
  <dcterms:modified xsi:type="dcterms:W3CDTF">2019-01-11T11:15:59Z</dcterms:modified>
</cp:coreProperties>
</file>